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016250" cy="34734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F6637-F2A1-4BDC-94AF-155EBB803D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25671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5000" y="2092680"/>
            <a:ext cx="25671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BDD9A-DF0A-4725-8DFA-26DCAE035B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540440" y="100476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5000" y="209268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540440" y="209268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DE0C4-C5D4-4178-B94A-AFDA7B2A4D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8265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93320" y="1004760"/>
            <a:ext cx="8265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961640" y="1004760"/>
            <a:ext cx="8265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5000" y="2092680"/>
            <a:ext cx="8265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93320" y="2092680"/>
            <a:ext cx="8265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961640" y="2092680"/>
            <a:ext cx="8265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95D9D4-ED4C-4DE2-BC97-2CECE16AE9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5000" y="1004760"/>
            <a:ext cx="2567160" cy="2082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FFB3E-189E-4984-80AE-E6AF686015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2567160" cy="208296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70F0F-44AE-403F-A9B2-E8A6921953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1252440" cy="208296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540440" y="1004760"/>
            <a:ext cx="1252440" cy="208296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349AC-7AB5-4A4B-B08A-6124D5F9BE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CCCEF-0995-42E5-BADC-5787951CF7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5000" y="310680"/>
            <a:ext cx="2567160" cy="267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34199-391B-45E5-B0F7-C480B7C5DD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540440" y="1004760"/>
            <a:ext cx="1252440" cy="208296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5000" y="209268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006C1-B0F4-43CA-8186-6ADE98450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1252440" cy="208296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540440" y="100476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540440" y="209268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4FEB3-8158-421E-B191-254E4AF566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5000" y="100476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540440" y="1004760"/>
            <a:ext cx="125244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5000" y="2092680"/>
            <a:ext cx="2567160" cy="99324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1D008-6728-4151-A378-BC29C4EE1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5000" y="310680"/>
            <a:ext cx="2567160" cy="57780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5000" y="1004760"/>
            <a:ext cx="2567160" cy="208296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rmAutofit fontScale="85000"/>
          </a:bodyPr>
          <a:p>
            <a:pPr marL="146880" indent="-146880">
              <a:spcBef>
                <a:spcPts val="400"/>
              </a:spcBef>
              <a:buClr>
                <a:srgbClr val="000000"/>
              </a:buClr>
              <a:buFont typeface="Times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316800" indent="-122400">
              <a:spcBef>
                <a:spcPts val="400"/>
              </a:spcBef>
              <a:buClr>
                <a:srgbClr val="000000"/>
              </a:buClr>
              <a:buFont typeface="Times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2" marL="485640" indent="-97200">
              <a:spcBef>
                <a:spcPts val="400"/>
              </a:spcBef>
              <a:buClr>
                <a:srgbClr val="000000"/>
              </a:buClr>
              <a:buFont typeface="Times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3" marL="681120" indent="-97200">
              <a:spcBef>
                <a:spcPts val="400"/>
              </a:spcBef>
              <a:buClr>
                <a:srgbClr val="000000"/>
              </a:buClr>
              <a:buFont typeface="Times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4" marL="876960" indent="-98280">
              <a:spcBef>
                <a:spcPts val="400"/>
              </a:spcBef>
              <a:buClr>
                <a:srgbClr val="000000"/>
              </a:buClr>
              <a:buFont typeface="Times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5" marL="876960" indent="-98280">
              <a:spcBef>
                <a:spcPts val="400"/>
              </a:spcBef>
              <a:buClr>
                <a:srgbClr val="000000"/>
              </a:buClr>
              <a:buFont typeface="Times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6" marL="876960" indent="-98280">
              <a:spcBef>
                <a:spcPts val="400"/>
              </a:spcBef>
              <a:buClr>
                <a:srgbClr val="000000"/>
              </a:buClr>
              <a:buFont typeface="Times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5360" y="3164040"/>
            <a:ext cx="628560" cy="23472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031400" y="3164040"/>
            <a:ext cx="954360" cy="23472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Autofit/>
          </a:bodyPr>
          <a:lstStyle>
            <a:lvl1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163240" y="3164040"/>
            <a:ext cx="628920" cy="234720"/>
          </a:xfrm>
          <a:prstGeom prst="rect">
            <a:avLst/>
          </a:prstGeom>
          <a:noFill/>
          <a:ln w="0">
            <a:noFill/>
          </a:ln>
        </p:spPr>
        <p:txBody>
          <a:bodyPr lIns="45720" rIns="45720" tIns="23040" bIns="2304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394BE2D-91E7-4C53-BDF8-F0DA99A8411E}" type="slidenum"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11160" y="158760"/>
            <a:ext cx="4189320" cy="3297960"/>
            <a:chOff x="-11160" y="158760"/>
            <a:chExt cx="4189320" cy="3297960"/>
          </a:xfrm>
        </p:grpSpPr>
        <p:sp>
          <p:nvSpPr>
            <p:cNvPr id="42" name=""/>
            <p:cNvSpPr/>
            <p:nvPr/>
          </p:nvSpPr>
          <p:spPr>
            <a:xfrm>
              <a:off x="69120" y="158760"/>
              <a:ext cx="3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.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749160" y="2860920"/>
              <a:ext cx="3429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TCTTAAgCgTTg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AgAATTCgCAACg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549440" y="2675160"/>
              <a:ext cx="0" cy="189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  <a:tailEnd len="sm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165320" y="2455920"/>
              <a:ext cx="5331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20560" y="2845080"/>
              <a:ext cx="533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’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292480" y="3149640"/>
              <a:ext cx="53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’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20560" y="3149640"/>
              <a:ext cx="533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’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292480" y="2845080"/>
              <a:ext cx="53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’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9120" y="2462400"/>
              <a:ext cx="3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.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1" name="" descr=""/>
            <p:cNvPicPr/>
            <p:nvPr/>
          </p:nvPicPr>
          <p:blipFill>
            <a:blip r:embed="rId1"/>
            <a:srcRect l="0" t="18941" r="0" b="0"/>
            <a:stretch/>
          </p:blipFill>
          <p:spPr>
            <a:xfrm>
              <a:off x="2265480" y="909720"/>
              <a:ext cx="407880" cy="927000"/>
            </a:xfrm>
            <a:prstGeom prst="rect">
              <a:avLst/>
            </a:prstGeom>
            <a:ln w="9360">
              <a:solidFill>
                <a:srgbClr val="808080"/>
              </a:solidFill>
              <a:miter/>
            </a:ln>
          </p:spPr>
        </p:pic>
        <p:sp>
          <p:nvSpPr>
            <p:cNvPr id="52" name=""/>
            <p:cNvSpPr/>
            <p:nvPr/>
          </p:nvSpPr>
          <p:spPr>
            <a:xfrm>
              <a:off x="2124360" y="6526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tl  N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33520" y="370080"/>
              <a:ext cx="234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quencing reac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09480" y="979560"/>
              <a:ext cx="76320" cy="381240"/>
            </a:xfrm>
            <a:custGeom>
              <a:avLst/>
              <a:gdLst>
                <a:gd name="textAreaLeft" fmla="*/ 22320 w 76320"/>
                <a:gd name="textAreaRight" fmla="*/ 76320 w 76320"/>
                <a:gd name="textAreaTop" fmla="*/ 15840 h 381240"/>
                <a:gd name="textAreaBottom" fmla="*/ 365400 h 381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-11160" y="998640"/>
              <a:ext cx="5446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76200" y="1132200"/>
              <a:ext cx="2332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7" name="" descr=""/>
            <p:cNvPicPr/>
            <p:nvPr/>
          </p:nvPicPr>
          <p:blipFill>
            <a:blip r:embed="rId2"/>
            <a:stretch/>
          </p:blipFill>
          <p:spPr>
            <a:xfrm>
              <a:off x="762120" y="903600"/>
              <a:ext cx="1218960" cy="966600"/>
            </a:xfrm>
            <a:prstGeom prst="rect">
              <a:avLst/>
            </a:prstGeom>
            <a:ln w="9360">
              <a:solidFill>
                <a:srgbClr val="808080"/>
              </a:solidFill>
              <a:miter/>
            </a:ln>
          </p:spPr>
        </p:pic>
        <p:sp>
          <p:nvSpPr>
            <p:cNvPr id="58" name=""/>
            <p:cNvSpPr/>
            <p:nvPr/>
          </p:nvSpPr>
          <p:spPr>
            <a:xfrm>
              <a:off x="609480" y="598680"/>
              <a:ext cx="182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 C g 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762120" y="598680"/>
              <a:ext cx="685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467000" y="65268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tl  N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149560" y="2046600"/>
              <a:ext cx="866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(Higher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xposure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29T16:47:34Z</dcterms:created>
  <dc:creator>Verónica Léautaud Sunderland</dc:creator>
  <dc:description/>
  <dc:language>en-US</dc:language>
  <cp:lastModifiedBy> </cp:lastModifiedBy>
  <dcterms:modified xsi:type="dcterms:W3CDTF">2007-11-26T16:17:47Z</dcterms:modified>
  <cp:revision>29</cp:revision>
  <dc:subject/>
  <dc:title>PowerPoint Presentation</dc:title>
</cp:coreProperties>
</file>